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200" d="100"/>
          <a:sy n="200" d="100"/>
        </p:scale>
        <p:origin x="396" y="-3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2024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799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1722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9930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2884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194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0916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837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5093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168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6827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EEB8A-76AA-436B-92B1-10927364221B}" type="datetimeFigureOut">
              <a:rPr lang="en-GB" smtClean="0"/>
              <a:t>2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B0D2E4-7043-449C-8219-5D08C5795C5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545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39882" y="2958592"/>
            <a:ext cx="37008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GB" dirty="0">
                <a:solidFill>
                  <a:srgbClr val="1C00EA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 </a:t>
            </a:r>
            <a:r>
              <a:rPr lang="en-GB" dirty="0">
                <a:solidFill>
                  <a:srgbClr val="24FF7B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STm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540502" y="5348047"/>
            <a:ext cx="3700800" cy="369332"/>
          </a:xfrm>
          <a:prstGeom prst="rect">
            <a:avLst/>
          </a:prstGeom>
          <a:solidFill>
            <a:schemeClr val="tx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GB" dirty="0">
                <a:solidFill>
                  <a:srgbClr val="1C00EA"/>
                </a:solidFill>
                <a:latin typeface="Arial"/>
                <a:cs typeface="Arial"/>
              </a:rPr>
              <a:t> </a:t>
            </a:r>
            <a:r>
              <a:rPr lang="en-GB" dirty="0">
                <a:solidFill>
                  <a:srgbClr val="FF0000"/>
                </a:solidFill>
                <a:latin typeface="Arial"/>
                <a:cs typeface="Arial"/>
              </a:rPr>
              <a:t>ZO-1 </a:t>
            </a:r>
            <a:r>
              <a:rPr lang="el-GR" dirty="0">
                <a:solidFill>
                  <a:srgbClr val="24FF7B"/>
                </a:solidFill>
                <a:latin typeface="Arial"/>
                <a:cs typeface="Arial"/>
              </a:rPr>
              <a:t>Δ</a:t>
            </a:r>
            <a:r>
              <a:rPr lang="en-GB" i="1" dirty="0" err="1">
                <a:solidFill>
                  <a:srgbClr val="24FF7B"/>
                </a:solidFill>
                <a:latin typeface="Arial"/>
                <a:cs typeface="Arial"/>
              </a:rPr>
              <a:t>prgH</a:t>
            </a:r>
            <a:r>
              <a:rPr lang="en-GB" dirty="0">
                <a:solidFill>
                  <a:srgbClr val="24FF7B"/>
                </a:solidFill>
                <a:latin typeface="Arial"/>
                <a:cs typeface="Arial"/>
              </a:rPr>
              <a:t> STm 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 contras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1923" y="3327924"/>
            <a:ext cx="1800000" cy="18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543" y="5717379"/>
            <a:ext cx="1798759" cy="180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502" y="5717379"/>
            <a:ext cx="1800000" cy="1800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882" y="3327924"/>
            <a:ext cx="1800000" cy="1800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390282" y="3271856"/>
            <a:ext cx="597900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  <a:latin typeface="Arial"/>
                <a:cs typeface="Arial"/>
              </a:rPr>
              <a:t>3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27030" y="3271857"/>
            <a:ext cx="53051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  <a:latin typeface="Arial"/>
                <a:cs typeface="Arial"/>
              </a:rPr>
              <a:t>2D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384914" y="5704050"/>
            <a:ext cx="597900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  <a:latin typeface="Arial"/>
                <a:cs typeface="Arial"/>
              </a:rPr>
              <a:t>3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521662" y="5704051"/>
            <a:ext cx="53051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  <a:latin typeface="Arial"/>
                <a:cs typeface="Arial"/>
              </a:rPr>
              <a:t>2D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088503" y="5030738"/>
            <a:ext cx="2016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en-GB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3092643" y="7440074"/>
            <a:ext cx="2016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en-GB" dirty="0"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988118" y="7417214"/>
            <a:ext cx="2016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en-GB" dirty="0"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988118" y="5027759"/>
            <a:ext cx="201600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en-GB" dirty="0">
              <a:latin typeface="Arial"/>
              <a:cs typeface="Arial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574E0C7-0DA0-44F0-A4B6-C465266D4865}"/>
              </a:ext>
            </a:extLst>
          </p:cNvPr>
          <p:cNvSpPr txBox="1"/>
          <p:nvPr/>
        </p:nvSpPr>
        <p:spPr>
          <a:xfrm>
            <a:off x="1149746" y="7617039"/>
            <a:ext cx="43802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ZO-1 localisation is unaffected in 2D and 3D enteroids infected with WT or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rg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T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t 4hpi Scale bars = 100 µm     </a:t>
            </a:r>
          </a:p>
        </p:txBody>
      </p:sp>
    </p:spTree>
    <p:extLst>
      <p:ext uri="{BB962C8B-B14F-4D97-AF65-F5344CB8AC3E}">
        <p14:creationId xmlns:p14="http://schemas.microsoft.com/office/powerpoint/2010/main" val="1423946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4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Sutton</dc:creator>
  <cp:lastModifiedBy>Kate Sutton</cp:lastModifiedBy>
  <cp:revision>2</cp:revision>
  <dcterms:created xsi:type="dcterms:W3CDTF">2023-08-23T08:45:36Z</dcterms:created>
  <dcterms:modified xsi:type="dcterms:W3CDTF">2023-08-23T09:14:57Z</dcterms:modified>
</cp:coreProperties>
</file>